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BECCD5"/>
    <a:srgbClr val="CF8A00"/>
    <a:srgbClr val="004987"/>
    <a:srgbClr val="1F4165"/>
    <a:srgbClr val="77BDDA"/>
    <a:srgbClr val="F2AF33"/>
    <a:srgbClr val="18466B"/>
    <a:srgbClr val="255E9C"/>
    <a:srgbClr val="35629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3918"/>
    <p:restoredTop sz="94672"/>
  </p:normalViewPr>
  <p:slideViewPr>
    <p:cSldViewPr snapToGrid="0" snapToObjects="1">
      <p:cViewPr>
        <p:scale>
          <a:sx n="70" d="100"/>
          <a:sy n="70" d="100"/>
        </p:scale>
        <p:origin x="-2244" y="7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190C74-1D60-0747-97FC-0F1D48081F58}" type="datetimeFigureOut">
              <a:rPr lang="en-US" smtClean="0"/>
              <a:pPr/>
              <a:t>2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9011F9-C3E4-7C44-9793-D975BF8AEEC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029055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1C661DF-CF15-D244-BC0A-DE5B6B1659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995312"/>
            <a:ext cx="5143500" cy="424462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E6F37D45-CFFF-4445-84ED-A6A0BA7AF9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3211604-25FB-6B48-BC1C-B8AAAC9FD4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pPr/>
              <a:t>2/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32AB625-AA0C-7E4A-84D0-B7C0702F3C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ACC6D91-F400-DE47-85B6-41C7DA660D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524923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CE2C3A5-5790-224F-B25C-FDAF7E270E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AA448749-1C2C-1248-B1FD-C6E0DB0C9A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DF59453-C529-2A43-9C87-23C487DE94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pPr/>
              <a:t>2/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49401FA-3E8A-8A4A-A605-CD701A3E6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B8FE4B8-7090-4449-9067-F27AD6ACE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060632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FC3D922B-7653-994D-9E3C-8B88DE1302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8B0B8825-C606-104B-9AB8-C79A2ABB14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369851A-B48B-1E4B-8759-FDD1275B87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pPr/>
              <a:t>2/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67446AC-AA5E-1D4D-BBD7-6FD3A8C081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704C99F-94E6-C540-BC82-573E2811A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71400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6B2753D-9B5F-FA41-BF0C-14197F70FD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38C06CFA-DC15-BC4C-A863-3D30C1B386A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23184FC-8155-F64F-9236-E0C369B53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pPr/>
              <a:t>2/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27BB90F-18B6-0246-8FCB-D2FAAAE8E9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5A1D673-35D0-0845-AA11-651A8D6EF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94267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C35A757-E6DC-5645-BEFB-07123FCA72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3039535"/>
            <a:ext cx="5915025" cy="507153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6815FDC-34E6-0449-B227-ABBDBE26B9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8159046"/>
            <a:ext cx="5915025" cy="266699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A45DDA5-BC2F-1E48-97B3-D7DF169FB3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pPr/>
              <a:t>2/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F55570E-86B6-E840-82FE-73E30AD84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789C461-8CA5-BB44-AFC1-A9520CA45A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35045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1E7CCBA-B2B7-2746-8556-047B431CF2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B9075EB-E075-A947-8531-DAB0E4C420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83D38BB2-29AE-C840-A0D3-A57C980BAF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7D068EE9-EE69-F34D-A31C-8CA7CF8DEB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pPr/>
              <a:t>2/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0D71B0C-6306-7943-A32C-450EAA2528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BB3D607-17AF-D44C-BE9D-9071A8AD6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2544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3FCBAEF-AD76-2341-BC29-D200C8E0E6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49112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6E8BA689-1DAA-9D4D-B84F-3333268AF4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613AA8B2-5487-454C-8B9E-CDD9B01CA2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5C70DB5E-96F8-6940-82B1-04E0821E780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E92E27B5-217E-5F42-9AFD-947E88B0D4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11611E61-9A84-BA4F-9E58-7A1F8DAD1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pPr/>
              <a:t>2/7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17BC3A4D-1A56-3C4C-9C0A-5C4F7CF4F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33455720-1F9F-714F-B950-C02E86045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18430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BA71B90-803E-734C-9142-6048CDB756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4F9199AA-E7E9-AD45-B517-E205B5215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pPr/>
              <a:t>2/7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25369C0C-8CAA-1B43-B9CD-1ABCB8E8F4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EB7D56B9-33DC-3A40-BE3C-60A1D9B61A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42213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99824C06-920D-C749-91F7-D48D1C3DF3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pPr/>
              <a:t>2/7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1703434D-74D6-094A-A2AC-5AF007CC2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4DAB40FD-EAB2-BC42-A3E0-5695DAEBB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98331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50BAF42-35E6-904E-8CF8-1CB95EB99E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FE82E01-DA20-9E47-B79B-9FBC800B87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8BFBD774-3744-7246-9717-5B34059DF6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64DF31F-E66D-F244-9821-4E8A3E839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pPr/>
              <a:t>2/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8A4FF396-0A4A-054B-A1FB-A0F840087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8A2051E-E83E-1447-B83A-4186333D2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812693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C199F9A-10B0-674B-828F-DE5EE331BE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E42F9205-AD99-5C4B-A768-95AE83540D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24A855C0-B12D-8740-B86B-50D885C62F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34D6A99-DC3F-564D-9587-454B22824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pPr/>
              <a:t>2/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21104A0-EDD7-0A43-8ADE-286456991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094CFDB-7429-A24B-8FB7-0B4BC0212D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13293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0787FE56-BCB7-5A4E-929C-46515A0367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649112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5FCF4DB-64B5-6F4C-9231-7AEE75DDE9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4BAD948-4601-7048-B36D-CBABDDB9555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844E6-3321-5B4E-8C29-3BBF9C216074}" type="datetimeFigureOut">
              <a:rPr lang="en-US" smtClean="0"/>
              <a:pPr/>
              <a:t>2/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C1E153F-12DF-F944-8A29-B22BA76099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11300179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757490F-5ACE-0B49-B89F-14B8E7C1CC5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7BD898-A793-B54D-9BA9-31711EA66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2765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AutoShape 2" descr="anal, anus, bowel, gastrointestinal tract, gut, intestine, rectum "/>
          <p:cNvSpPr>
            <a:spLocks noChangeAspect="1" noChangeArrowheads="1"/>
          </p:cNvSpPr>
          <p:nvPr/>
        </p:nvSpPr>
        <p:spPr bwMode="auto">
          <a:xfrm>
            <a:off x="87511" y="-256822"/>
            <a:ext cx="171450" cy="541868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639275" y="5411729"/>
            <a:ext cx="210242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Patients with </a:t>
            </a:r>
            <a:r>
              <a:rPr lang="en-US" sz="1600" b="1" kern="50" dirty="0" smtClean="0">
                <a:latin typeface="Times New Roman" pitchFamily="18" charset="0"/>
                <a:ea typeface="宋体"/>
                <a:cs typeface="Times New Roman" pitchFamily="18" charset="0"/>
              </a:rPr>
              <a:t>defective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MMR (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dMMR, n=30)</a:t>
            </a:r>
          </a:p>
        </p:txBody>
      </p:sp>
      <p:sp>
        <p:nvSpPr>
          <p:cNvPr id="20" name="矩形 19"/>
          <p:cNvSpPr/>
          <p:nvPr/>
        </p:nvSpPr>
        <p:spPr>
          <a:xfrm>
            <a:off x="4008713" y="5411729"/>
            <a:ext cx="210242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Patients with proficient MMR (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pMMR, n=239)</a:t>
            </a:r>
          </a:p>
        </p:txBody>
      </p:sp>
      <p:sp>
        <p:nvSpPr>
          <p:cNvPr id="21" name="矩形 20"/>
          <p:cNvSpPr/>
          <p:nvPr/>
        </p:nvSpPr>
        <p:spPr>
          <a:xfrm>
            <a:off x="639271" y="8512193"/>
            <a:ext cx="230023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PS-Matched patients with dMMR(n=29)</a:t>
            </a:r>
          </a:p>
        </p:txBody>
      </p:sp>
      <p:sp>
        <p:nvSpPr>
          <p:cNvPr id="22" name="矩形 21"/>
          <p:cNvSpPr/>
          <p:nvPr/>
        </p:nvSpPr>
        <p:spPr>
          <a:xfrm>
            <a:off x="3988117" y="8512193"/>
            <a:ext cx="2364131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PS-Matched patients with pMMR (n=29)</a:t>
            </a:r>
          </a:p>
        </p:txBody>
      </p:sp>
      <p:sp>
        <p:nvSpPr>
          <p:cNvPr id="23" name="矩形 22"/>
          <p:cNvSpPr/>
          <p:nvPr/>
        </p:nvSpPr>
        <p:spPr>
          <a:xfrm>
            <a:off x="675348" y="4295117"/>
            <a:ext cx="4856052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Immunohistochemistry for four proteins: MLH1, MSH2, MSH6 and PMS2 (N=269)</a:t>
            </a:r>
          </a:p>
        </p:txBody>
      </p:sp>
      <p:sp>
        <p:nvSpPr>
          <p:cNvPr id="25" name="矩形 24"/>
          <p:cNvSpPr/>
          <p:nvPr/>
        </p:nvSpPr>
        <p:spPr>
          <a:xfrm>
            <a:off x="1071646" y="7011450"/>
            <a:ext cx="4856052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Propensity score (PS) was calculated for each patient using a logistic regression model</a:t>
            </a:r>
            <a:endParaRPr lang="en-US" altLang="zh-CN" sz="1600" b="1" dirty="0" smtClean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8" name="直接箭头连接符 27"/>
          <p:cNvCxnSpPr/>
          <p:nvPr/>
        </p:nvCxnSpPr>
        <p:spPr>
          <a:xfrm rot="10800000" flipV="1">
            <a:off x="2268345" y="4944342"/>
            <a:ext cx="830641" cy="640000"/>
          </a:xfrm>
          <a:prstGeom prst="straightConnector1">
            <a:avLst/>
          </a:prstGeom>
          <a:ln w="381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9"/>
          <p:cNvCxnSpPr/>
          <p:nvPr/>
        </p:nvCxnSpPr>
        <p:spPr>
          <a:xfrm>
            <a:off x="3104621" y="4944341"/>
            <a:ext cx="830641" cy="640000"/>
          </a:xfrm>
          <a:prstGeom prst="straightConnector1">
            <a:avLst/>
          </a:prstGeom>
          <a:ln w="381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箭头连接符 31"/>
          <p:cNvCxnSpPr/>
          <p:nvPr/>
        </p:nvCxnSpPr>
        <p:spPr>
          <a:xfrm rot="5400000">
            <a:off x="1599876" y="6797278"/>
            <a:ext cx="640000" cy="2818"/>
          </a:xfrm>
          <a:prstGeom prst="straightConnector1">
            <a:avLst/>
          </a:prstGeom>
          <a:ln w="381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箭头连接符 32"/>
          <p:cNvCxnSpPr/>
          <p:nvPr/>
        </p:nvCxnSpPr>
        <p:spPr>
          <a:xfrm rot="5400000">
            <a:off x="4387104" y="6797278"/>
            <a:ext cx="640000" cy="2818"/>
          </a:xfrm>
          <a:prstGeom prst="straightConnector1">
            <a:avLst/>
          </a:prstGeom>
          <a:ln w="381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箭头连接符 33"/>
          <p:cNvCxnSpPr/>
          <p:nvPr/>
        </p:nvCxnSpPr>
        <p:spPr>
          <a:xfrm rot="10800000" flipV="1">
            <a:off x="2303631" y="7744191"/>
            <a:ext cx="830641" cy="768000"/>
          </a:xfrm>
          <a:prstGeom prst="straightConnector1">
            <a:avLst/>
          </a:prstGeom>
          <a:ln w="381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箭头连接符 35"/>
          <p:cNvCxnSpPr/>
          <p:nvPr/>
        </p:nvCxnSpPr>
        <p:spPr>
          <a:xfrm>
            <a:off x="3366072" y="7750877"/>
            <a:ext cx="830641" cy="768000"/>
          </a:xfrm>
          <a:prstGeom prst="straightConnector1">
            <a:avLst/>
          </a:prstGeom>
          <a:ln w="381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矩形 50"/>
          <p:cNvSpPr/>
          <p:nvPr/>
        </p:nvSpPr>
        <p:spPr>
          <a:xfrm>
            <a:off x="4693444" y="2451581"/>
            <a:ext cx="1937199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smtClean="0">
                <a:solidFill>
                  <a:srgbClr val="FFFFFF"/>
                </a:solidFill>
                <a:latin typeface="Times New Roman" pitchFamily="18" charset="0"/>
                <a:cs typeface="Times New Roman" pitchFamily="18" charset="0"/>
              </a:rPr>
              <a:t>Recurrence free and overall survival (OS) for matched MMR patients</a:t>
            </a:r>
            <a:endParaRPr lang="zh-CN" altLang="en-US" sz="1600" dirty="0">
              <a:solidFill>
                <a:srgbClr val="FFFFFF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1174406" y="2928495"/>
            <a:ext cx="3857936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atients who had received neoadjuvant chemoradiotherapy(N=428)</a:t>
            </a:r>
          </a:p>
        </p:txBody>
      </p:sp>
      <p:sp>
        <p:nvSpPr>
          <p:cNvPr id="38" name="矩形 37"/>
          <p:cNvSpPr/>
          <p:nvPr/>
        </p:nvSpPr>
        <p:spPr>
          <a:xfrm>
            <a:off x="1174406" y="1652603"/>
            <a:ext cx="3857936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LARC patients who had undergone radical rectal cancer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surgery</a:t>
            </a:r>
            <a:endParaRPr lang="en-US" altLang="zh-CN" sz="1600" dirty="0" smtClean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9" name="直接箭头连接符 38"/>
          <p:cNvCxnSpPr/>
          <p:nvPr/>
        </p:nvCxnSpPr>
        <p:spPr>
          <a:xfrm rot="5400000">
            <a:off x="2771941" y="2634382"/>
            <a:ext cx="640000" cy="2818"/>
          </a:xfrm>
          <a:prstGeom prst="straightConnector1">
            <a:avLst/>
          </a:prstGeom>
          <a:ln w="381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箭头连接符 39"/>
          <p:cNvCxnSpPr/>
          <p:nvPr/>
        </p:nvCxnSpPr>
        <p:spPr>
          <a:xfrm rot="5400000">
            <a:off x="2771941" y="3898644"/>
            <a:ext cx="640000" cy="2818"/>
          </a:xfrm>
          <a:prstGeom prst="straightConnector1">
            <a:avLst/>
          </a:prstGeom>
          <a:ln w="381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3838421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7</TotalTime>
  <Words>88</Words>
  <Application>Microsoft Macintosh PowerPoint</Application>
  <PresentationFormat>自定义</PresentationFormat>
  <Paragraphs>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li Schmidt</dc:creator>
  <cp:lastModifiedBy>Sam</cp:lastModifiedBy>
  <cp:revision>33</cp:revision>
  <dcterms:created xsi:type="dcterms:W3CDTF">2020-02-13T15:45:58Z</dcterms:created>
  <dcterms:modified xsi:type="dcterms:W3CDTF">2022-02-07T05:42:59Z</dcterms:modified>
</cp:coreProperties>
</file>